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D5A81DD-78B7-3F3D-9CA5-96E802A0CF70}"/>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BA1B70EF-0627-DAAC-476C-6C6EEAB8121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A25EE9F5-779D-DCE1-B262-FDA050B8CC0C}"/>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5" name="页脚占位符 4">
            <a:extLst>
              <a:ext uri="{FF2B5EF4-FFF2-40B4-BE49-F238E27FC236}">
                <a16:creationId xmlns:a16="http://schemas.microsoft.com/office/drawing/2014/main" id="{C7946627-782A-A1D7-5592-B0077435BCB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E4D80A5-09E8-5052-F801-D9BEEDD8A306}"/>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37698554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5838432-9657-CB41-2957-12B382296EDC}"/>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22B37DF0-6608-70B4-0865-16573FE773C8}"/>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04A5359F-CBAB-B8C4-28BF-080FD7C809CC}"/>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5" name="页脚占位符 4">
            <a:extLst>
              <a:ext uri="{FF2B5EF4-FFF2-40B4-BE49-F238E27FC236}">
                <a16:creationId xmlns:a16="http://schemas.microsoft.com/office/drawing/2014/main" id="{C756C36D-80EA-9F26-F47C-F24A2869F67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A66B2F2-E630-CB7B-9292-9EBA27C2EAB1}"/>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32963985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A905C133-3A23-E3B5-D3AF-4490AAD9215B}"/>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BDD8CE61-65EE-7B96-8B6F-8E6292DAE35C}"/>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57EE0AA-0536-37EB-203E-13D07EEBA15C}"/>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5" name="页脚占位符 4">
            <a:extLst>
              <a:ext uri="{FF2B5EF4-FFF2-40B4-BE49-F238E27FC236}">
                <a16:creationId xmlns:a16="http://schemas.microsoft.com/office/drawing/2014/main" id="{6E2CA733-C44E-6E58-016F-B03B5B40ED9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AEB239C-F681-CAE0-728E-CAF037998FDE}"/>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3823938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95FA885-C3F6-5B23-EAC8-8DA5B7AA2E6E}"/>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D7E8886-955B-B7F0-9D40-77CD7FE5F8DA}"/>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59EB787-57EE-C980-42ED-C2FC2A9486BA}"/>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5" name="页脚占位符 4">
            <a:extLst>
              <a:ext uri="{FF2B5EF4-FFF2-40B4-BE49-F238E27FC236}">
                <a16:creationId xmlns:a16="http://schemas.microsoft.com/office/drawing/2014/main" id="{A1FB1EEF-D7A7-3729-B8D7-2ADE352BE82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364D983-7C47-1F47-CEA5-2999BD1C39D4}"/>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9220241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0E6D99F-D000-4F95-1026-AAF16778CC9D}"/>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56B3E837-02D8-FA49-1771-BB6E7DD2946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B28D1918-CC70-F6D2-CADF-AC88CDE906AD}"/>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5" name="页脚占位符 4">
            <a:extLst>
              <a:ext uri="{FF2B5EF4-FFF2-40B4-BE49-F238E27FC236}">
                <a16:creationId xmlns:a16="http://schemas.microsoft.com/office/drawing/2014/main" id="{0116C84D-E4E4-59C5-C525-6B9DF7943DE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48D5F63-B629-75F8-1B5F-FD7C03BB1A0D}"/>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25692094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F03028A-9EA1-0836-B944-58249BB4B16A}"/>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AE79AEFF-C48D-0D42-66BE-BC08729BD946}"/>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674DFCFC-2AA1-1AD9-42C0-E73CE94E86E8}"/>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04B1C00F-681C-4D8E-AA6C-67A24C5A5AC8}"/>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6" name="页脚占位符 5">
            <a:extLst>
              <a:ext uri="{FF2B5EF4-FFF2-40B4-BE49-F238E27FC236}">
                <a16:creationId xmlns:a16="http://schemas.microsoft.com/office/drawing/2014/main" id="{A5A3CA27-4B2E-6051-B944-483B127FFB4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5F96BCE-3326-2179-2F1A-3E0A696A172D}"/>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17887191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9ACE0EE-6E95-3719-50E6-C20B8D1C2AF1}"/>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83C958C3-F0BF-A7E3-C209-26C5997F1B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02F99F2E-83AA-D5D4-92D0-C54470A5E7B5}"/>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77573B88-0739-48EF-2F23-1E7A679E4B4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0086BA1B-6EF1-152F-082E-B8585170634B}"/>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ECF7691A-7F50-A84E-0DC2-577E50BE2990}"/>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8" name="页脚占位符 7">
            <a:extLst>
              <a:ext uri="{FF2B5EF4-FFF2-40B4-BE49-F238E27FC236}">
                <a16:creationId xmlns:a16="http://schemas.microsoft.com/office/drawing/2014/main" id="{3EABC599-711D-158B-CB32-BF2D9B816BAB}"/>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719B96F8-7D3B-2E9B-0ED1-37EF125A4D0A}"/>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7628200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C7C147D-394C-405F-C15D-CDE4774EA140}"/>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343975E1-0396-7C51-9A2A-EEAF8551EB60}"/>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4" name="页脚占位符 3">
            <a:extLst>
              <a:ext uri="{FF2B5EF4-FFF2-40B4-BE49-F238E27FC236}">
                <a16:creationId xmlns:a16="http://schemas.microsoft.com/office/drawing/2014/main" id="{0FBDEBE5-21F0-755B-F642-200EE0B7E264}"/>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74491F39-5903-2B05-8B16-5DEA909FA05B}"/>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900059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02729CE0-DDB8-CCAC-762E-42F81E84B1AE}"/>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3" name="页脚占位符 2">
            <a:extLst>
              <a:ext uri="{FF2B5EF4-FFF2-40B4-BE49-F238E27FC236}">
                <a16:creationId xmlns:a16="http://schemas.microsoft.com/office/drawing/2014/main" id="{B5C3EB2D-70DA-6640-7B02-3BB250EEEC9C}"/>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24FC6117-6F62-67A0-0336-566756F125A0}"/>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19110594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29D0F8D-0F36-D10C-D51D-96C9D7DC4B57}"/>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33A63F22-7C9E-1E42-EB41-E25ED6782B2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13B2BC93-A93D-78C1-B58C-188C9E3868A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8AC526F8-5AB4-4F95-09FC-DA38FA3E9E13}"/>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6" name="页脚占位符 5">
            <a:extLst>
              <a:ext uri="{FF2B5EF4-FFF2-40B4-BE49-F238E27FC236}">
                <a16:creationId xmlns:a16="http://schemas.microsoft.com/office/drawing/2014/main" id="{DA2D367A-E6AB-C4A7-A8F8-36DF54E7DD56}"/>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0E11688D-9028-CCBA-D02A-6CFF3BF2DD80}"/>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38827725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22E69B8-2F0B-393B-AC2A-A2CBFEEE439A}"/>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93EECE03-9E22-06EB-26D6-C014025CF83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1D956A9E-678C-C51A-A39E-82ADBFD8B44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98D3BA87-C358-1622-DF56-262BEBAE96AC}"/>
              </a:ext>
            </a:extLst>
          </p:cNvPr>
          <p:cNvSpPr>
            <a:spLocks noGrp="1"/>
          </p:cNvSpPr>
          <p:nvPr>
            <p:ph type="dt" sz="half" idx="10"/>
          </p:nvPr>
        </p:nvSpPr>
        <p:spPr/>
        <p:txBody>
          <a:bodyPr/>
          <a:lstStyle/>
          <a:p>
            <a:fld id="{4E81D1B9-C883-45E3-89C4-A69D23A1CCD6}" type="datetimeFigureOut">
              <a:rPr lang="zh-CN" altLang="en-US" smtClean="0"/>
              <a:t>2023/2/11</a:t>
            </a:fld>
            <a:endParaRPr lang="zh-CN" altLang="en-US"/>
          </a:p>
        </p:txBody>
      </p:sp>
      <p:sp>
        <p:nvSpPr>
          <p:cNvPr id="6" name="页脚占位符 5">
            <a:extLst>
              <a:ext uri="{FF2B5EF4-FFF2-40B4-BE49-F238E27FC236}">
                <a16:creationId xmlns:a16="http://schemas.microsoft.com/office/drawing/2014/main" id="{DAD0D6EB-96EA-5CD6-E36B-31736A584721}"/>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A951111-46A2-892F-FCE6-134FB379846B}"/>
              </a:ext>
            </a:extLst>
          </p:cNvPr>
          <p:cNvSpPr>
            <a:spLocks noGrp="1"/>
          </p:cNvSpPr>
          <p:nvPr>
            <p:ph type="sldNum" sz="quarter" idx="12"/>
          </p:nvPr>
        </p:nvSpPr>
        <p:spPr/>
        <p:txBody>
          <a:body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38044937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73AC79A4-D4B8-A13F-9AA6-3A7A3D5E570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21AA6584-FF63-C6A1-40CA-33F88C6E354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10A91158-2C94-EC07-7D09-8EEAC02A589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81D1B9-C883-45E3-89C4-A69D23A1CCD6}" type="datetimeFigureOut">
              <a:rPr lang="zh-CN" altLang="en-US" smtClean="0"/>
              <a:t>2023/2/11</a:t>
            </a:fld>
            <a:endParaRPr lang="zh-CN" altLang="en-US"/>
          </a:p>
        </p:txBody>
      </p:sp>
      <p:sp>
        <p:nvSpPr>
          <p:cNvPr id="5" name="页脚占位符 4">
            <a:extLst>
              <a:ext uri="{FF2B5EF4-FFF2-40B4-BE49-F238E27FC236}">
                <a16:creationId xmlns:a16="http://schemas.microsoft.com/office/drawing/2014/main" id="{1336CC6E-8C4A-A84B-4A61-CFA4C4EDD8F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69FAAD5D-370E-D583-587D-8DF68741444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72762D1-200D-4CF1-B9F5-201708BEF23A}" type="slidenum">
              <a:rPr lang="zh-CN" altLang="en-US" smtClean="0"/>
              <a:t>‹#›</a:t>
            </a:fld>
            <a:endParaRPr lang="zh-CN" altLang="en-US"/>
          </a:p>
        </p:txBody>
      </p:sp>
    </p:spTree>
    <p:extLst>
      <p:ext uri="{BB962C8B-B14F-4D97-AF65-F5344CB8AC3E}">
        <p14:creationId xmlns:p14="http://schemas.microsoft.com/office/powerpoint/2010/main" val="6056858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4BF82A39-775B-0249-1006-9B0FE975A1A4}"/>
              </a:ext>
            </a:extLst>
          </p:cNvPr>
          <p:cNvSpPr txBox="1"/>
          <p:nvPr/>
        </p:nvSpPr>
        <p:spPr>
          <a:xfrm>
            <a:off x="4674267" y="2962130"/>
            <a:ext cx="6534336" cy="3693319"/>
          </a:xfrm>
          <a:prstGeom prst="rect">
            <a:avLst/>
          </a:prstGeom>
          <a:noFill/>
        </p:spPr>
        <p:txBody>
          <a:bodyPr wrap="square">
            <a:spAutoFit/>
          </a:bodyPr>
          <a:lstStyle/>
          <a:p>
            <a:pPr eaLnBrk="1" hangingPunct="1">
              <a:defRPr/>
            </a:pPr>
            <a:r>
              <a:rPr lang="en-US" altLang="zh-CN" b="1" kern="100" dirty="0">
                <a:latin typeface="Times New Roman" panose="02020603050405020304" pitchFamily="18" charset="0"/>
                <a:ea typeface="等线" panose="02010600030101010101" pitchFamily="2" charset="-122"/>
              </a:rPr>
              <a:t>Fig. S1 Results of classification and conserved domains predicted using the SMART web site.</a:t>
            </a:r>
          </a:p>
          <a:p>
            <a:pPr algn="just" eaLnBrk="1" hangingPunct="1">
              <a:defRPr/>
            </a:pPr>
            <a:r>
              <a:rPr lang="en-US" altLang="zh-CN" kern="100" dirty="0">
                <a:latin typeface="Times New Roman" panose="02020603050405020304" pitchFamily="18" charset="0"/>
                <a:ea typeface="等线" panose="02010600030101010101" pitchFamily="2" charset="-122"/>
              </a:rPr>
              <a:t>The CBS domain, the transmembrane region, the </a:t>
            </a:r>
            <a:r>
              <a:rPr lang="en-US" altLang="zh-CN" kern="100" dirty="0" err="1">
                <a:latin typeface="Times New Roman" panose="02020603050405020304" pitchFamily="18" charset="0"/>
                <a:ea typeface="等线" panose="02010600030101010101" pitchFamily="2" charset="-122"/>
              </a:rPr>
              <a:t>Phox</a:t>
            </a:r>
            <a:r>
              <a:rPr lang="en-US" altLang="zh-CN" kern="100" dirty="0">
                <a:latin typeface="Times New Roman" panose="02020603050405020304" pitchFamily="18" charset="0"/>
                <a:ea typeface="等线" panose="02010600030101010101" pitchFamily="2" charset="-122"/>
              </a:rPr>
              <a:t> and Bem1 (PB1) domain and the complexity region are represented by the pentagonal element, the blue column, the triangular element and the pink rectangular element, respectively. Other domains include DUF21,voltage chloride channel (Voltage CLC), and Carbohydrate binding domain (CBD).The classification according to one pair or two pairs of CBS domains (CBSX and CBSCBS). Other classifications are named by the other structural domains they contain for labeling, such as CBSCLC, CBSCBSCBD, CBSDUF1 and CBSCBSPB1</a:t>
            </a:r>
            <a:r>
              <a:rPr lang="en-US" altLang="zh-CN" b="1" kern="100" dirty="0">
                <a:latin typeface="Times New Roman" panose="02020603050405020304" pitchFamily="18" charset="0"/>
                <a:ea typeface="等线" panose="02010600030101010101" pitchFamily="2" charset="-122"/>
              </a:rPr>
              <a:t>. </a:t>
            </a:r>
            <a:r>
              <a:rPr lang="en-US" altLang="zh-CN" kern="100" dirty="0">
                <a:latin typeface="Times New Roman" panose="02020603050405020304" pitchFamily="18" charset="0"/>
                <a:ea typeface="等线" panose="02010600030101010101" pitchFamily="2" charset="-122"/>
              </a:rPr>
              <a:t>The 66 identified members corresponding to this protein are shown in parentheses.</a:t>
            </a:r>
          </a:p>
        </p:txBody>
      </p:sp>
      <p:pic>
        <p:nvPicPr>
          <p:cNvPr id="7" name="图片 6">
            <a:extLst>
              <a:ext uri="{FF2B5EF4-FFF2-40B4-BE49-F238E27FC236}">
                <a16:creationId xmlns:a16="http://schemas.microsoft.com/office/drawing/2014/main" id="{E8B937FE-B6BF-3DDA-DEC4-2C56575EBE0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7859" y="4"/>
            <a:ext cx="4032708" cy="6858000"/>
          </a:xfrm>
          <a:prstGeom prst="rect">
            <a:avLst/>
          </a:prstGeom>
        </p:spPr>
      </p:pic>
    </p:spTree>
    <p:extLst>
      <p:ext uri="{BB962C8B-B14F-4D97-AF65-F5344CB8AC3E}">
        <p14:creationId xmlns:p14="http://schemas.microsoft.com/office/powerpoint/2010/main" val="33188454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2FAD6A45-F3E8-0238-A988-7EC1F7CD19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618" y="-1"/>
            <a:ext cx="9013847" cy="6747029"/>
          </a:xfrm>
          <a:prstGeom prst="rect">
            <a:avLst/>
          </a:prstGeom>
        </p:spPr>
      </p:pic>
      <p:sp>
        <p:nvSpPr>
          <p:cNvPr id="6" name="文本框 5">
            <a:extLst>
              <a:ext uri="{FF2B5EF4-FFF2-40B4-BE49-F238E27FC236}">
                <a16:creationId xmlns:a16="http://schemas.microsoft.com/office/drawing/2014/main" id="{82DAEC31-B650-EE6D-EA0C-3D8EBF36E1B1}"/>
              </a:ext>
            </a:extLst>
          </p:cNvPr>
          <p:cNvSpPr txBox="1"/>
          <p:nvPr/>
        </p:nvSpPr>
        <p:spPr>
          <a:xfrm>
            <a:off x="9116465" y="3068661"/>
            <a:ext cx="2832879" cy="3416320"/>
          </a:xfrm>
          <a:prstGeom prst="rect">
            <a:avLst/>
          </a:prstGeom>
          <a:noFill/>
        </p:spPr>
        <p:txBody>
          <a:bodyPr wrap="square">
            <a:spAutoFit/>
          </a:bodyPr>
          <a:lstStyle/>
          <a:p>
            <a:pPr eaLnBrk="1" hangingPunct="1">
              <a:defRPr/>
            </a:pPr>
            <a:r>
              <a:rPr lang="en-US" altLang="zh-CN" b="1" kern="100" dirty="0">
                <a:latin typeface="Times New Roman" panose="02020603050405020304" pitchFamily="18" charset="0"/>
                <a:ea typeface="等线" panose="02010600030101010101" pitchFamily="2" charset="-122"/>
              </a:rPr>
              <a:t>Fig. S2 The Ka/Ks value of paralog pairs of </a:t>
            </a:r>
            <a:r>
              <a:rPr lang="en-US" altLang="zh-CN" b="1" i="1" kern="100" dirty="0" err="1">
                <a:latin typeface="Times New Roman" panose="02020603050405020304" pitchFamily="18" charset="0"/>
                <a:ea typeface="等线" panose="02010600030101010101" pitchFamily="2" charset="-122"/>
              </a:rPr>
              <a:t>TaCBS</a:t>
            </a:r>
            <a:r>
              <a:rPr lang="en-US" altLang="zh-CN" b="1" kern="100" dirty="0">
                <a:latin typeface="Times New Roman" panose="02020603050405020304" pitchFamily="18" charset="0"/>
                <a:ea typeface="等线" panose="02010600030101010101" pitchFamily="2" charset="-122"/>
              </a:rPr>
              <a:t> in wheat. </a:t>
            </a:r>
          </a:p>
          <a:p>
            <a:pPr eaLnBrk="1" hangingPunct="1">
              <a:defRPr/>
            </a:pPr>
            <a:r>
              <a:rPr lang="en-US" altLang="zh-CN" kern="100" dirty="0">
                <a:latin typeface="Times New Roman" panose="02020603050405020304" pitchFamily="18" charset="0"/>
                <a:ea typeface="等线" panose="02010600030101010101" pitchFamily="2" charset="-122"/>
              </a:rPr>
              <a:t>The black dots refer to Ka values, the red dots refer to Ks values, and Ka/Ks values are shown by green inverted triangles. The horizontal line and vertical line indicate paralog pairs and the values of Ka, Ks, Ka/Ks, respectively.</a:t>
            </a:r>
          </a:p>
        </p:txBody>
      </p:sp>
    </p:spTree>
    <p:extLst>
      <p:ext uri="{BB962C8B-B14F-4D97-AF65-F5344CB8AC3E}">
        <p14:creationId xmlns:p14="http://schemas.microsoft.com/office/powerpoint/2010/main" val="2723328470"/>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79</TotalTime>
  <Words>198</Words>
  <Application>Microsoft Office PowerPoint</Application>
  <PresentationFormat>宽屏</PresentationFormat>
  <Paragraphs>4</Paragraphs>
  <Slides>2</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2</vt:i4>
      </vt:variant>
    </vt:vector>
  </HeadingPairs>
  <TitlesOfParts>
    <vt:vector size="7" baseType="lpstr">
      <vt:lpstr>等线</vt:lpstr>
      <vt:lpstr>等线 Light</vt:lpstr>
      <vt:lpstr>Arial</vt:lpstr>
      <vt:lpstr>Times New Roman</vt:lpstr>
      <vt:lpstr>Office 主题​​</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Z LIU</dc:creator>
  <cp:lastModifiedBy>HZ LIU</cp:lastModifiedBy>
  <cp:revision>3</cp:revision>
  <dcterms:created xsi:type="dcterms:W3CDTF">2022-11-12T07:05:09Z</dcterms:created>
  <dcterms:modified xsi:type="dcterms:W3CDTF">2023-02-11T10:56:01Z</dcterms:modified>
</cp:coreProperties>
</file>